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charts/chartEx3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rts/chartEx4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ppt/charts/chartEx5.xml" ContentType="application/vnd.ms-office.chartex+xml"/>
  <Override PartName="/ppt/charts/style5.xml" ContentType="application/vnd.ms-office.chartstyle+xml"/>
  <Override PartName="/ppt/charts/colors5.xml" ContentType="application/vnd.ms-office.chartcolorstyle+xml"/>
  <Override PartName="/ppt/charts/chartEx6.xml" ContentType="application/vnd.ms-office.chartex+xml"/>
  <Override PartName="/ppt/charts/style6.xml" ContentType="application/vnd.ms-office.chartstyle+xml"/>
  <Override PartName="/ppt/charts/colors6.xml" ContentType="application/vnd.ms-office.chartcolorstyle+xml"/>
  <Override PartName="/ppt/charts/chartEx7.xml" ContentType="application/vnd.ms-office.chartex+xml"/>
  <Override PartName="/ppt/charts/style7.xml" ContentType="application/vnd.ms-office.chartstyle+xml"/>
  <Override PartName="/ppt/charts/colors7.xml" ContentType="application/vnd.ms-office.chartcolorstyle+xml"/>
  <Override PartName="/ppt/charts/chartEx8.xml" ContentType="application/vnd.ms-office.chartex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60" r:id="rId4"/>
    <p:sldId id="261" r:id="rId5"/>
    <p:sldId id="262" r:id="rId6"/>
    <p:sldId id="265" r:id="rId7"/>
    <p:sldId id="257" r:id="rId8"/>
    <p:sldId id="263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277" autoAdjust="0"/>
    <p:restoredTop sz="94660"/>
  </p:normalViewPr>
  <p:slideViewPr>
    <p:cSldViewPr snapToGrid="0">
      <p:cViewPr varScale="1">
        <p:scale>
          <a:sx n="56" d="100"/>
          <a:sy n="56" d="100"/>
        </p:scale>
        <p:origin x="3096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E:\OMEGA%203%20TOPI\GR%20DC\Dati%20Excel%20NEUROPROTECTION\uniti\Splash%20test%201a%20e%202a.xlsx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E:\OMEGA%203%20TOPI\GR%20DC\Dati%20Excel%20NEUROPROTECTION\uniti\Splash%20test%201a%20e%202a.xlsx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E:\OMEGA%203%20TOPI\GR%20DC\Dati%20Excel%20NEUROPROTECTION\uniti\Social%20Interactions%20Neuroprotezione%20Annacarmen%20-%20Davide%20(sobinati%20davide)%202.xls" TargetMode="External"/></Relationships>
</file>

<file path=ppt/charts/_rels/chartEx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E:\OMEGA%203%20TOPI\GR%20DC\Dati%20Excel%20NEUROPROTECTION\uniti\Social%20Interactions%20Neuroprotezione%20Annacarmen%20-%20Davide%20(sobinati%20davide)%202.xls" TargetMode="External"/></Relationships>
</file>

<file path=ppt/charts/_rels/chartEx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file:///E:\OMEGA%203%20TOPI\GR%20DC\Dati%20Excel%20NEUROPROTECTION\uniti\Social%20Interactions%20Neuroprotezione%20Annacarmen%20-%20Davide%20(sobinati%20davide)%202.xls" TargetMode="External"/></Relationships>
</file>

<file path=ppt/charts/_rels/chartEx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file:///E:\OMEGA%203%20TOPI\GR%20DC\Dati%20Excel%20NEUROPROTECTION\uniti\Social%20Interactions%20Neuroprotezione%20Annacarmen%20-%20Davide%20(sobinati%20davide)%202.xls" TargetMode="External"/></Relationships>
</file>

<file path=ppt/charts/_rels/chartEx7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microsoft.com/office/2011/relationships/chartStyle" Target="style7.xml"/><Relationship Id="rId1" Type="http://schemas.openxmlformats.org/officeDocument/2006/relationships/oleObject" Target="file:///E:\OMEGA%203%20TOPI\GR%20DC\Dati%20Excel%20NEUROPROTECTION\uniti\Hidden%20food%20test%201a%20e%202a%20mandata.xlsx" TargetMode="External"/></Relationships>
</file>

<file path=ppt/charts/_rels/chartEx8.xml.rels><?xml version="1.0" encoding="UTF-8" standalone="yes"?>
<Relationships xmlns="http://schemas.openxmlformats.org/package/2006/relationships"><Relationship Id="rId3" Type="http://schemas.microsoft.com/office/2011/relationships/chartColorStyle" Target="colors8.xml"/><Relationship Id="rId2" Type="http://schemas.microsoft.com/office/2011/relationships/chartStyle" Target="style8.xml"/><Relationship Id="rId1" Type="http://schemas.openxmlformats.org/officeDocument/2006/relationships/oleObject" Target="file:///E:\OMEGA%203%20TOPI\GR%20DC\Dati%20Excel%20NEUROPROTECTION\uniti\Predator%20odor%201a%20e%202a%20mandata.xlsx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definitivo!$R$2:$R$43</cx:f>
        <cx:lvl ptCount="42">
          <cx:pt idx="0">oil sham</cx:pt>
          <cx:pt idx="1">oil sham</cx:pt>
          <cx:pt idx="2">oil sham</cx:pt>
          <cx:pt idx="3">oil sham</cx:pt>
          <cx:pt idx="4">oil sham</cx:pt>
          <cx:pt idx="5">oil sham</cx:pt>
          <cx:pt idx="6">oil sham</cx:pt>
          <cx:pt idx="7">oil sham</cx:pt>
          <cx:pt idx="8">oil sham</cx:pt>
          <cx:pt idx="9">oil sham</cx:pt>
          <cx:pt idx="10">oil sham</cx:pt>
          <cx:pt idx="11">oil sham</cx:pt>
          <cx:pt idx="12">n-3 PUFA sham</cx:pt>
          <cx:pt idx="13">n-3 PUFA sham</cx:pt>
          <cx:pt idx="14">n-3 PUFA sham</cx:pt>
          <cx:pt idx="15">n-3 PUFA sham</cx:pt>
          <cx:pt idx="16">n-3 PUFA sham</cx:pt>
          <cx:pt idx="17">n-3 PUFA sham</cx:pt>
          <cx:pt idx="18">n-3 PUFA sham</cx:pt>
          <cx:pt idx="19">n-3 PUFA sham</cx:pt>
          <cx:pt idx="20">n-3 PUFA sham</cx:pt>
          <cx:pt idx="21">n-3 PUFA sham</cx:pt>
          <cx:pt idx="22">oil sap</cx:pt>
          <cx:pt idx="23">oil sap</cx:pt>
          <cx:pt idx="24">oil sap</cx:pt>
          <cx:pt idx="25">oil sap</cx:pt>
          <cx:pt idx="26">oil sap</cx:pt>
          <cx:pt idx="27">oil sap</cx:pt>
          <cx:pt idx="28">oil sap</cx:pt>
          <cx:pt idx="29">oil sap</cx:pt>
          <cx:pt idx="30">oil sap</cx:pt>
          <cx:pt idx="31">oil sap</cx:pt>
          <cx:pt idx="32">n-3 PUFA sap</cx:pt>
          <cx:pt idx="33">n-3 PUFA sap</cx:pt>
          <cx:pt idx="34">n-3 PUFA sap</cx:pt>
          <cx:pt idx="35">n-3 PUFA sap</cx:pt>
          <cx:pt idx="36">n-3 PUFA sap</cx:pt>
          <cx:pt idx="37">n-3 PUFA sap</cx:pt>
          <cx:pt idx="38">n-3 PUFA sap</cx:pt>
          <cx:pt idx="39">n-3 PUFA sap</cx:pt>
          <cx:pt idx="40">n-3 PUFA sap</cx:pt>
          <cx:pt idx="41">n-3 PUFA sap</cx:pt>
        </cx:lvl>
      </cx:strDim>
      <cx:numDim type="val">
        <cx:f>definitivo!$T$2:$T$43</cx:f>
        <cx:lvl ptCount="42" formatCode="Standard">
          <cx:pt idx="0">14</cx:pt>
          <cx:pt idx="1">47</cx:pt>
          <cx:pt idx="2">18</cx:pt>
          <cx:pt idx="3">10</cx:pt>
          <cx:pt idx="4">19</cx:pt>
          <cx:pt idx="5">9</cx:pt>
          <cx:pt idx="6">43</cx:pt>
          <cx:pt idx="7">109</cx:pt>
          <cx:pt idx="8">19</cx:pt>
          <cx:pt idx="9">34</cx:pt>
          <cx:pt idx="10">72</cx:pt>
          <cx:pt idx="11">62</cx:pt>
          <cx:pt idx="12">62</cx:pt>
          <cx:pt idx="13">26</cx:pt>
          <cx:pt idx="14">41</cx:pt>
          <cx:pt idx="15">35</cx:pt>
          <cx:pt idx="16">56</cx:pt>
          <cx:pt idx="17">77</cx:pt>
          <cx:pt idx="18">28</cx:pt>
          <cx:pt idx="19">40</cx:pt>
          <cx:pt idx="20">35</cx:pt>
          <cx:pt idx="21">40</cx:pt>
          <cx:pt idx="22">44</cx:pt>
          <cx:pt idx="23">36</cx:pt>
          <cx:pt idx="24">37</cx:pt>
          <cx:pt idx="25">10</cx:pt>
          <cx:pt idx="26">30</cx:pt>
          <cx:pt idx="27">27</cx:pt>
          <cx:pt idx="28">38</cx:pt>
          <cx:pt idx="29">38</cx:pt>
          <cx:pt idx="30">36</cx:pt>
          <cx:pt idx="31">95</cx:pt>
          <cx:pt idx="32">26</cx:pt>
          <cx:pt idx="33">15</cx:pt>
          <cx:pt idx="34">41</cx:pt>
          <cx:pt idx="35">34</cx:pt>
          <cx:pt idx="36">58</cx:pt>
          <cx:pt idx="37">14</cx:pt>
          <cx:pt idx="38">32</cx:pt>
          <cx:pt idx="39">41</cx:pt>
          <cx:pt idx="40">16</cx:pt>
          <cx:pt idx="41">38</cx:pt>
        </cx:lvl>
      </cx:numDim>
    </cx:data>
  </cx:chartData>
  <cx:chart>
    <cx:title pos="t" align="ctr" overlay="0">
      <cx:tx>
        <cx:txData>
          <cx:v>Grooming duration (s)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/>
          </a:pPr>
          <a:r>
            <a:rPr lang="it-IT" sz="1400" b="0" i="0" u="none" strike="noStrike" baseline="0" dirty="0">
              <a:solidFill>
                <a:sysClr val="windowText" lastClr="000000">
                  <a:lumMod val="65000"/>
                  <a:lumOff val="35000"/>
                </a:sysClr>
              </a:solidFill>
              <a:latin typeface="Calibri" panose="020F0502020204030204"/>
            </a:rPr>
            <a:t>Grooming duration (s)</a:t>
          </a:r>
        </a:p>
      </cx:txPr>
    </cx:title>
    <cx:plotArea>
      <cx:plotAreaRegion>
        <cx:series layoutId="boxWhisker" uniqueId="{DF37102F-0D4B-4C29-9BCA-10F9A7ED19D3}">
          <cx:tx>
            <cx:txData>
              <cx:f>definitivo!$T$1</cx:f>
              <cx:v>Duration</cx:v>
            </cx:txData>
          </cx:tx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ckLabels/>
      </cx:axis>
      <cx:axis id="1">
        <cx:valScaling/>
        <cx:majorGridlines/>
        <cx:tickLabels/>
      </cx:axis>
    </cx:plotArea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definitivo!$R$2:$R$43</cx:f>
        <cx:lvl ptCount="42">
          <cx:pt idx="0">oil sham</cx:pt>
          <cx:pt idx="1">oil sham</cx:pt>
          <cx:pt idx="2">oil sham</cx:pt>
          <cx:pt idx="3">oil sham</cx:pt>
          <cx:pt idx="4">oil sham</cx:pt>
          <cx:pt idx="5">oil sham</cx:pt>
          <cx:pt idx="6">oil sham</cx:pt>
          <cx:pt idx="7">oil sham</cx:pt>
          <cx:pt idx="8">oil sham</cx:pt>
          <cx:pt idx="9">oil sham</cx:pt>
          <cx:pt idx="10">oil sham</cx:pt>
          <cx:pt idx="11">oil sham</cx:pt>
          <cx:pt idx="12">n-3 PUFA sham</cx:pt>
          <cx:pt idx="13">n-3 PUFA sham</cx:pt>
          <cx:pt idx="14">n-3 PUFA sham</cx:pt>
          <cx:pt idx="15">n-3 PUFA sham</cx:pt>
          <cx:pt idx="16">n-3 PUFA sham</cx:pt>
          <cx:pt idx="17">n-3 PUFA sham</cx:pt>
          <cx:pt idx="18">n-3 PUFA sham</cx:pt>
          <cx:pt idx="19">n-3 PUFA sham</cx:pt>
          <cx:pt idx="20">n-3 PUFA sham</cx:pt>
          <cx:pt idx="21">n-3 PUFA sham</cx:pt>
          <cx:pt idx="22">oil sap</cx:pt>
          <cx:pt idx="23">oil sap</cx:pt>
          <cx:pt idx="24">oil sap</cx:pt>
          <cx:pt idx="25">oil sap</cx:pt>
          <cx:pt idx="26">oil sap</cx:pt>
          <cx:pt idx="27">oil sap</cx:pt>
          <cx:pt idx="28">oil sap</cx:pt>
          <cx:pt idx="29">oil sap</cx:pt>
          <cx:pt idx="30">oil sap</cx:pt>
          <cx:pt idx="31">oil sap</cx:pt>
          <cx:pt idx="32">n-3 PUFA sap</cx:pt>
          <cx:pt idx="33">n-3 PUFA sap</cx:pt>
          <cx:pt idx="34">n-3 PUFA sap</cx:pt>
          <cx:pt idx="35">n-3 PUFA sap</cx:pt>
          <cx:pt idx="36">n-3 PUFA sap</cx:pt>
          <cx:pt idx="37">n-3 PUFA sap</cx:pt>
          <cx:pt idx="38">n-3 PUFA sap</cx:pt>
          <cx:pt idx="39">n-3 PUFA sap</cx:pt>
          <cx:pt idx="40">n-3 PUFA sap</cx:pt>
          <cx:pt idx="41">n-3 PUFA sap</cx:pt>
        </cx:lvl>
      </cx:strDim>
      <cx:numDim type="val">
        <cx:f>definitivo!$S$2:$S$43</cx:f>
        <cx:lvl ptCount="42" formatCode="Standard">
          <cx:pt idx="0">7</cx:pt>
          <cx:pt idx="1">22</cx:pt>
          <cx:pt idx="2">10</cx:pt>
          <cx:pt idx="3">3</cx:pt>
          <cx:pt idx="4">8</cx:pt>
          <cx:pt idx="5">4</cx:pt>
          <cx:pt idx="6">20</cx:pt>
          <cx:pt idx="7">9</cx:pt>
          <cx:pt idx="8">5</cx:pt>
          <cx:pt idx="9">16</cx:pt>
          <cx:pt idx="10">13</cx:pt>
          <cx:pt idx="11">20</cx:pt>
          <cx:pt idx="12">33</cx:pt>
          <cx:pt idx="13">13</cx:pt>
          <cx:pt idx="14">21</cx:pt>
          <cx:pt idx="15">9</cx:pt>
          <cx:pt idx="16">23</cx:pt>
          <cx:pt idx="17">19</cx:pt>
          <cx:pt idx="18">15</cx:pt>
          <cx:pt idx="19">22</cx:pt>
          <cx:pt idx="20">7</cx:pt>
          <cx:pt idx="21">16</cx:pt>
          <cx:pt idx="22">11</cx:pt>
          <cx:pt idx="23">18</cx:pt>
          <cx:pt idx="24">16</cx:pt>
          <cx:pt idx="25">3</cx:pt>
          <cx:pt idx="26">15</cx:pt>
          <cx:pt idx="27">11</cx:pt>
          <cx:pt idx="28">8</cx:pt>
          <cx:pt idx="29">11</cx:pt>
          <cx:pt idx="30">7</cx:pt>
          <cx:pt idx="31">22</cx:pt>
          <cx:pt idx="32">9</cx:pt>
          <cx:pt idx="33">6</cx:pt>
          <cx:pt idx="34">17</cx:pt>
          <cx:pt idx="35">22</cx:pt>
          <cx:pt idx="36">32</cx:pt>
          <cx:pt idx="37">8</cx:pt>
          <cx:pt idx="38">7</cx:pt>
          <cx:pt idx="39">6</cx:pt>
          <cx:pt idx="40">4</cx:pt>
          <cx:pt idx="41">5</cx:pt>
        </cx:lvl>
      </cx:numDim>
    </cx:data>
  </cx:chartData>
  <cx:chart>
    <cx:title pos="t" align="ctr" overlay="0">
      <cx:tx>
        <cx:txData>
          <cx:v>Grooming frequency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/>
          </a:pPr>
          <a:r>
            <a:rPr lang="it-IT" sz="1400" b="0" i="0" u="none" strike="noStrike" baseline="0" dirty="0">
              <a:solidFill>
                <a:sysClr val="windowText" lastClr="000000">
                  <a:lumMod val="65000"/>
                  <a:lumOff val="35000"/>
                </a:sysClr>
              </a:solidFill>
              <a:latin typeface="Calibri" panose="020F0502020204030204"/>
            </a:rPr>
            <a:t>Grooming frequency</a:t>
          </a:r>
        </a:p>
      </cx:txPr>
    </cx:title>
    <cx:plotArea>
      <cx:plotAreaRegion>
        <cx:series layoutId="boxWhisker" uniqueId="{DBACFDBE-589B-4A48-8AB1-40D69B43D9AB}">
          <cx:tx>
            <cx:txData>
              <cx:f>definitivo!$S$1</cx:f>
              <cx:v>Frequency</cx:v>
            </cx:txData>
          </cx:tx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ckLabels/>
      </cx:axis>
      <cx:axis id="1">
        <cx:valScaling/>
        <cx:majorGridlines/>
        <cx:tickLabels/>
      </cx:axis>
    </cx:plotArea>
  </cx:chart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figure definitive'!$B$50:$B$91</cx:f>
        <cx:lvl ptCount="42">
          <cx:pt idx="0">oil sham</cx:pt>
          <cx:pt idx="1">oil sham</cx:pt>
          <cx:pt idx="2">oil sham</cx:pt>
          <cx:pt idx="3">oil sham</cx:pt>
          <cx:pt idx="4">oil sham</cx:pt>
          <cx:pt idx="5">oil sham</cx:pt>
          <cx:pt idx="6">oil sham</cx:pt>
          <cx:pt idx="7">oil sham</cx:pt>
          <cx:pt idx="8">oil sham</cx:pt>
          <cx:pt idx="9">oil sham</cx:pt>
          <cx:pt idx="10">oil sham</cx:pt>
          <cx:pt idx="11">oil sham</cx:pt>
          <cx:pt idx="12">n-3 PUFA sham</cx:pt>
          <cx:pt idx="13">n-3 PUFA sham</cx:pt>
          <cx:pt idx="14">n-3 PUFA sham</cx:pt>
          <cx:pt idx="15">n-3 PUFA sham</cx:pt>
          <cx:pt idx="16">n-3 PUFA sham</cx:pt>
          <cx:pt idx="17">n-3 PUFA sham</cx:pt>
          <cx:pt idx="18">n-3 PUFA sham</cx:pt>
          <cx:pt idx="19">n-3 PUFA sham</cx:pt>
          <cx:pt idx="20">n-3 PUFA sham</cx:pt>
          <cx:pt idx="21">n-3 PUFA sham</cx:pt>
          <cx:pt idx="22">oil sap</cx:pt>
          <cx:pt idx="23">oil sap</cx:pt>
          <cx:pt idx="24">oil sap</cx:pt>
          <cx:pt idx="25">oil sap</cx:pt>
          <cx:pt idx="26">oil sap</cx:pt>
          <cx:pt idx="27">oil sap</cx:pt>
          <cx:pt idx="28">oil sap</cx:pt>
          <cx:pt idx="29">oil sap</cx:pt>
          <cx:pt idx="30">oil sap</cx:pt>
          <cx:pt idx="31">oil sap</cx:pt>
          <cx:pt idx="32">n-3 PUFA sap</cx:pt>
          <cx:pt idx="33">n-3 PUFA sap</cx:pt>
          <cx:pt idx="34">n-3 PUFA sap</cx:pt>
          <cx:pt idx="35">n-3 PUFA sap</cx:pt>
          <cx:pt idx="36">n-3 PUFA sap</cx:pt>
          <cx:pt idx="37">n-3 PUFA sap</cx:pt>
          <cx:pt idx="38">n-3 PUFA sap</cx:pt>
          <cx:pt idx="39">n-3 PUFA sap</cx:pt>
          <cx:pt idx="40">n-3 PUFA sap</cx:pt>
          <cx:pt idx="41">n-3 PUFA sap</cx:pt>
        </cx:lvl>
      </cx:strDim>
      <cx:numDim type="val">
        <cx:f>'figure definitive'!$C$50:$C$91</cx:f>
        <cx:lvl ptCount="42" formatCode="Standard">
          <cx:pt idx="0">100.48</cx:pt>
          <cx:pt idx="1">92.52000000000001</cx:pt>
          <cx:pt idx="2">136.84</cx:pt>
          <cx:pt idx="3">154.51999999999998</cx:pt>
          <cx:pt idx="4">144.20000000000002</cx:pt>
          <cx:pt idx="5">109.27999999999999</cx:pt>
          <cx:pt idx="6">74.107437000000004</cx:pt>
          <cx:pt idx="7">173.27326599999998</cx:pt>
          <cx:pt idx="8">86.586588999999989</cx:pt>
          <cx:pt idx="9">39.079999999999998</cx:pt>
          <cx:pt idx="10">98.680000000000007</cx:pt>
          <cx:pt idx="11">71.640000000000001</cx:pt>
          <cx:pt idx="12">83.799999999999983</cx:pt>
          <cx:pt idx="13">130.88</cx:pt>
          <cx:pt idx="14">76.519999999999982</cx:pt>
          <cx:pt idx="15">146.28</cx:pt>
          <cx:pt idx="16">97.11999999999999</cx:pt>
          <cx:pt idx="17">75.079999999999998</cx:pt>
          <cx:pt idx="18">84.920000000000002</cx:pt>
          <cx:pt idx="19">99.920000000000002</cx:pt>
          <cx:pt idx="20">78.840000000000003</cx:pt>
          <cx:pt idx="21">112.16000000000001</cx:pt>
          <cx:pt idx="22">60.600000000000001</cx:pt>
          <cx:pt idx="23">103.56</cx:pt>
          <cx:pt idx="24">120.16</cx:pt>
          <cx:pt idx="25">127.95999999999999</cx:pt>
          <cx:pt idx="26">91.524857999999995</cx:pt>
          <cx:pt idx="27">93.793791999999982</cx:pt>
          <cx:pt idx="28">67.033697999999987</cx:pt>
          <cx:pt idx="29">71.504832999999991</cx:pt>
          <cx:pt idx="30">78.14481099999999</cx:pt>
          <cx:pt idx="31">213.16</cx:pt>
          <cx:pt idx="32">44.759999999999998</cx:pt>
          <cx:pt idx="33">179.11999999999998</cx:pt>
          <cx:pt idx="34">154.03999999999999</cx:pt>
          <cx:pt idx="35">87.080000000000013</cx:pt>
          <cx:pt idx="36">76.576574999999991</cx:pt>
          <cx:pt idx="37">108.87554299999999</cx:pt>
          <cx:pt idx="38">116.14948699999999</cx:pt>
          <cx:pt idx="39">146.713379</cx:pt>
          <cx:pt idx="40">161.96195500000002</cx:pt>
          <cx:pt idx="41">85.018352000000007</cx:pt>
        </cx:lvl>
      </cx:numDim>
    </cx:data>
  </cx:chartData>
  <cx:chart>
    <cx:title pos="t" align="ctr" overlay="0">
      <cx:tx>
        <cx:txData>
          <cx:v>Duration (s)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/>
          </a:pPr>
          <a:r>
            <a:rPr lang="it-IT" sz="1400" b="0" i="0" u="none" strike="noStrike" baseline="0" dirty="0">
              <a:solidFill>
                <a:sysClr val="windowText" lastClr="000000">
                  <a:lumMod val="65000"/>
                  <a:lumOff val="35000"/>
                </a:sysClr>
              </a:solidFill>
              <a:latin typeface="Calibri" panose="020F0502020204030204"/>
            </a:rPr>
            <a:t>Duration (s)</a:t>
          </a:r>
        </a:p>
      </cx:txPr>
    </cx:title>
    <cx:plotArea>
      <cx:plotAreaRegion>
        <cx:series layoutId="boxWhisker" uniqueId="{517F8636-4C75-489D-82D1-C59C9DCE7838}">
          <cx:dataId val="0"/>
          <cx:layoutPr>
            <cx:statistics quartileMethod="exclusive"/>
          </cx:layoutPr>
        </cx:series>
      </cx:plotAreaRegion>
      <cx:axis id="0">
        <cx:catScaling gapWidth="1"/>
        <cx:tickLabels/>
      </cx:axis>
      <cx:axis id="1">
        <cx:valScaling/>
        <cx:majorGridlines/>
        <cx:tickLabels/>
      </cx:axis>
    </cx:plotArea>
  </cx:chart>
</cx:chartSpace>
</file>

<file path=ppt/charts/chartEx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figure definitive'!$B$2:$B$43</cx:f>
        <cx:lvl ptCount="42">
          <cx:pt idx="0">oil sham</cx:pt>
          <cx:pt idx="1">oil sham</cx:pt>
          <cx:pt idx="2">oil sham</cx:pt>
          <cx:pt idx="3">oil sham</cx:pt>
          <cx:pt idx="4">oil sham</cx:pt>
          <cx:pt idx="5">oil sham</cx:pt>
          <cx:pt idx="6">oil sham</cx:pt>
          <cx:pt idx="7">oil sham</cx:pt>
          <cx:pt idx="8">oil sham</cx:pt>
          <cx:pt idx="9">oil sham</cx:pt>
          <cx:pt idx="10">oil sham</cx:pt>
          <cx:pt idx="11">oil sham</cx:pt>
          <cx:pt idx="12">n-3 PUFA sham</cx:pt>
          <cx:pt idx="13">n-3 PUFA sham</cx:pt>
          <cx:pt idx="14">n-3 PUFA sham</cx:pt>
          <cx:pt idx="15">n-3 PUFA sham</cx:pt>
          <cx:pt idx="16">n-3 PUFA sham</cx:pt>
          <cx:pt idx="17">n-3 PUFA sham</cx:pt>
          <cx:pt idx="18">n-3 PUFA sham</cx:pt>
          <cx:pt idx="19">n-3 PUFA sham</cx:pt>
          <cx:pt idx="20">n-3 PUFA sham</cx:pt>
          <cx:pt idx="21">n-3 PUFA sham</cx:pt>
          <cx:pt idx="22">oil sap</cx:pt>
          <cx:pt idx="23">oil sap</cx:pt>
          <cx:pt idx="24">oil sap</cx:pt>
          <cx:pt idx="25">oil sap</cx:pt>
          <cx:pt idx="26">oil sap</cx:pt>
          <cx:pt idx="27">oil sap</cx:pt>
          <cx:pt idx="28">oil sap</cx:pt>
          <cx:pt idx="29">oil sap</cx:pt>
          <cx:pt idx="30">oil sap</cx:pt>
          <cx:pt idx="31">oil sap</cx:pt>
          <cx:pt idx="32">n-3 PUFA sap</cx:pt>
          <cx:pt idx="33">n-3 PUFA sap</cx:pt>
          <cx:pt idx="34">n-3 PUFA sap</cx:pt>
          <cx:pt idx="35">n-3 PUFA sap</cx:pt>
          <cx:pt idx="36">n-3 PUFA sap</cx:pt>
          <cx:pt idx="37">n-3 PUFA sap</cx:pt>
          <cx:pt idx="38">n-3 PUFA sap</cx:pt>
          <cx:pt idx="39">n-3 PUFA sap</cx:pt>
          <cx:pt idx="40">n-3 PUFA sap</cx:pt>
          <cx:pt idx="41">n-3 PUFA sap</cx:pt>
        </cx:lvl>
      </cx:strDim>
      <cx:numDim type="val">
        <cx:f>'figure definitive'!$C$2:$C$43</cx:f>
        <cx:lvl ptCount="42" formatCode="Standard">
          <cx:pt idx="0">52</cx:pt>
          <cx:pt idx="1">56</cx:pt>
          <cx:pt idx="2">63</cx:pt>
          <cx:pt idx="3">74</cx:pt>
          <cx:pt idx="4">66</cx:pt>
          <cx:pt idx="5">52</cx:pt>
          <cx:pt idx="6">65</cx:pt>
          <cx:pt idx="7">63</cx:pt>
          <cx:pt idx="8">69</cx:pt>
          <cx:pt idx="9">43</cx:pt>
          <cx:pt idx="10">52</cx:pt>
          <cx:pt idx="11">50</cx:pt>
          <cx:pt idx="12">44</cx:pt>
          <cx:pt idx="13">56</cx:pt>
          <cx:pt idx="14">47</cx:pt>
          <cx:pt idx="15">66</cx:pt>
          <cx:pt idx="16">67</cx:pt>
          <cx:pt idx="17">63</cx:pt>
          <cx:pt idx="18">67</cx:pt>
          <cx:pt idx="19">75</cx:pt>
          <cx:pt idx="20">69</cx:pt>
          <cx:pt idx="21">68</cx:pt>
          <cx:pt idx="22">28</cx:pt>
          <cx:pt idx="23">46</cx:pt>
          <cx:pt idx="24">57</cx:pt>
          <cx:pt idx="25">60</cx:pt>
          <cx:pt idx="26">64</cx:pt>
          <cx:pt idx="27">81</cx:pt>
          <cx:pt idx="28">69</cx:pt>
          <cx:pt idx="29">59</cx:pt>
          <cx:pt idx="30">59</cx:pt>
          <cx:pt idx="31">76</cx:pt>
          <cx:pt idx="32">26</cx:pt>
          <cx:pt idx="33">56</cx:pt>
          <cx:pt idx="34">63</cx:pt>
          <cx:pt idx="35">41</cx:pt>
          <cx:pt idx="36">71</cx:pt>
          <cx:pt idx="37">80</cx:pt>
          <cx:pt idx="38">80</cx:pt>
          <cx:pt idx="39">101</cx:pt>
          <cx:pt idx="40">91</cx:pt>
          <cx:pt idx="41">76</cx:pt>
        </cx:lvl>
      </cx:numDim>
    </cx:data>
  </cx:chartData>
  <cx:chart>
    <cx:title pos="t" align="ctr" overlay="0">
      <cx:tx>
        <cx:txData>
          <cx:v>Frequency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/>
          </a:pPr>
          <a:r>
            <a:rPr lang="it-IT" sz="1400" b="0" i="0" u="none" strike="noStrike" baseline="0">
              <a:solidFill>
                <a:sysClr val="windowText" lastClr="000000">
                  <a:lumMod val="65000"/>
                  <a:lumOff val="35000"/>
                </a:sysClr>
              </a:solidFill>
              <a:latin typeface="Calibri" panose="020F0502020204030204"/>
            </a:rPr>
            <a:t>Frequency</a:t>
          </a:r>
        </a:p>
      </cx:txPr>
    </cx:title>
    <cx:plotArea>
      <cx:plotAreaRegion>
        <cx:series layoutId="boxWhisker" uniqueId="{6BB06ECB-E59E-4746-BF68-6AF7792812FA}">
          <cx:dataId val="0"/>
          <cx:layoutPr>
            <cx:statistics quartileMethod="exclusive"/>
          </cx:layoutPr>
        </cx:series>
      </cx:plotAreaRegion>
      <cx:axis id="0">
        <cx:catScaling gapWidth="1"/>
        <cx:tickLabels/>
      </cx:axis>
      <cx:axis id="1">
        <cx:valScaling/>
        <cx:majorGridlines/>
        <cx:tickLabels/>
      </cx:axis>
    </cx:plotArea>
  </cx:chart>
</cx:chartSpace>
</file>

<file path=ppt/charts/chartEx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figure definitive'!$D$50:$D$91</cx:f>
        <cx:lvl ptCount="42">
          <cx:pt idx="0">oil sham</cx:pt>
          <cx:pt idx="1">oil sham</cx:pt>
          <cx:pt idx="2">oil sham</cx:pt>
          <cx:pt idx="3">oil sham</cx:pt>
          <cx:pt idx="4">oil sham</cx:pt>
          <cx:pt idx="5">oil sham</cx:pt>
          <cx:pt idx="6">oil sham</cx:pt>
          <cx:pt idx="7">oil sham</cx:pt>
          <cx:pt idx="8">oil sham</cx:pt>
          <cx:pt idx="9">oil sham</cx:pt>
          <cx:pt idx="10">oil sham</cx:pt>
          <cx:pt idx="11">oil sham</cx:pt>
          <cx:pt idx="12">n-3 PUFA sham</cx:pt>
          <cx:pt idx="13">n-3 PUFA sham</cx:pt>
          <cx:pt idx="14">n-3 PUFA sham</cx:pt>
          <cx:pt idx="15">n-3 PUFA sham</cx:pt>
          <cx:pt idx="16">n-3 PUFA sham</cx:pt>
          <cx:pt idx="17">n-3 PUFA sham</cx:pt>
          <cx:pt idx="18">n-3 PUFA sham</cx:pt>
          <cx:pt idx="19">n-3 PUFA sham</cx:pt>
          <cx:pt idx="20">n-3 PUFA sham</cx:pt>
          <cx:pt idx="21">n-3 PUFA sham</cx:pt>
          <cx:pt idx="22">oil sap</cx:pt>
          <cx:pt idx="23">oil sap</cx:pt>
          <cx:pt idx="24">oil sap</cx:pt>
          <cx:pt idx="25">oil sap</cx:pt>
          <cx:pt idx="26">oil sap</cx:pt>
          <cx:pt idx="27">oil sap</cx:pt>
          <cx:pt idx="28">oil sap</cx:pt>
          <cx:pt idx="29">oil sap</cx:pt>
          <cx:pt idx="30">oil sap</cx:pt>
          <cx:pt idx="31">oil sap</cx:pt>
          <cx:pt idx="32">n-3 PUFA sap</cx:pt>
          <cx:pt idx="33">n-3 PUFA sap</cx:pt>
          <cx:pt idx="34">n-3 PUFA sap</cx:pt>
          <cx:pt idx="35">n-3 PUFA sap</cx:pt>
          <cx:pt idx="36">n-3 PUFA sap</cx:pt>
          <cx:pt idx="37">n-3 PUFA sap</cx:pt>
          <cx:pt idx="38">n-3 PUFA sap</cx:pt>
          <cx:pt idx="39">n-3 PUFA sap</cx:pt>
          <cx:pt idx="40">n-3 PUFA sap</cx:pt>
          <cx:pt idx="41">n-3 PUFA sap</cx:pt>
        </cx:lvl>
      </cx:strDim>
      <cx:numDim type="val">
        <cx:f>'figure definitive'!$E$50:$E$91</cx:f>
        <cx:lvl ptCount="42" formatCode="Standard">
          <cx:pt idx="0">491.75999999999999</cx:pt>
          <cx:pt idx="1">504.67999999999995</cx:pt>
          <cx:pt idx="2">461.48000000000002</cx:pt>
          <cx:pt idx="3">444.95999999999998</cx:pt>
          <cx:pt idx="4">455.48000000000002</cx:pt>
          <cx:pt idx="5">489.68000000000001</cx:pt>
          <cx:pt idx="6">525.35869300000002</cx:pt>
          <cx:pt idx="7">425.658998</cx:pt>
          <cx:pt idx="8">512.34567399999992</cx:pt>
          <cx:pt idx="9">559.84000000000003</cx:pt>
          <cx:pt idx="10">500.32000000000005</cx:pt>
          <cx:pt idx="11">524.63999999999999</cx:pt>
          <cx:pt idx="12">508.67999999999995</cx:pt>
          <cx:pt idx="13">468.68000000000006</cx:pt>
          <cx:pt idx="14">523.07999999999993</cx:pt>
          <cx:pt idx="15">446.83999999999992</cx:pt>
          <cx:pt idx="16">501.56000000000006</cx:pt>
          <cx:pt idx="17">524.15999999999997</cx:pt>
          <cx:pt idx="18">514.4799999999999</cx:pt>
          <cx:pt idx="19">495</cx:pt>
          <cx:pt idx="20">491.00000000000006</cx:pt>
          <cx:pt idx="21">487.32000000000005</cx:pt>
          <cx:pt idx="22">537.36000000000013</cx:pt>
          <cx:pt idx="23">493.32000000000005</cx:pt>
          <cx:pt idx="24">420.36000000000001</cx:pt>
          <cx:pt idx="25">470.27999999999992</cx:pt>
          <cx:pt idx="26">507.34067199999993</cx:pt>
          <cx:pt idx="27">504.73807099999999</cx:pt>
          <cx:pt idx="28">531.76509900000008</cx:pt>
          <cx:pt idx="29">527.52753000000007</cx:pt>
          <cx:pt idx="30">520.85418600000003</cx:pt>
          <cx:pt idx="31">385.31999999999994</cx:pt>
          <cx:pt idx="32">550.5200000000001</cx:pt>
          <cx:pt idx="33">418.12</cx:pt>
          <cx:pt idx="34">445.16000000000003</cx:pt>
          <cx:pt idx="35">509.16000000000003</cx:pt>
          <cx:pt idx="36">522.85618899999986</cx:pt>
          <cx:pt idx="37">490.35702099999997</cx:pt>
          <cx:pt idx="38">483.04971000000006</cx:pt>
          <cx:pt idx="39">452.285617</cx:pt>
          <cx:pt idx="40">437.57090799999997</cx:pt>
          <cx:pt idx="41">514.68134599999996</cx:pt>
        </cx:lvl>
      </cx:numDim>
    </cx:data>
  </cx:chartData>
  <cx:chart>
    <cx:title pos="t" align="ctr" overlay="0">
      <cx:tx>
        <cx:txData>
          <cx:v>Duration (s)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/>
          </a:pPr>
          <a:r>
            <a:rPr lang="it-IT" sz="1400" b="0" i="0" u="none" strike="noStrike" baseline="0" dirty="0">
              <a:solidFill>
                <a:sysClr val="windowText" lastClr="000000">
                  <a:lumMod val="65000"/>
                  <a:lumOff val="35000"/>
                </a:sysClr>
              </a:solidFill>
              <a:latin typeface="Calibri" panose="020F0502020204030204"/>
            </a:rPr>
            <a:t>Duration (s)</a:t>
          </a:r>
        </a:p>
      </cx:txPr>
    </cx:title>
    <cx:plotArea>
      <cx:plotAreaRegion>
        <cx:series layoutId="boxWhisker" uniqueId="{C2C75E9C-6067-4CE8-A3FD-4E6701ED0733}">
          <cx:dataId val="0"/>
          <cx:layoutPr>
            <cx:statistics quartileMethod="exclusive"/>
          </cx:layoutPr>
        </cx:series>
      </cx:plotAreaRegion>
      <cx:axis id="0">
        <cx:catScaling gapWidth="1"/>
        <cx:tickLabels/>
      </cx:axis>
      <cx:axis id="1">
        <cx:valScaling/>
        <cx:majorGridlines/>
        <cx:tickLabels/>
      </cx:axis>
    </cx:plotArea>
  </cx:chart>
</cx:chartSpace>
</file>

<file path=ppt/charts/chartEx6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figure definitive'!$D$2:$D$43</cx:f>
        <cx:lvl ptCount="42">
          <cx:pt idx="0">oil sham</cx:pt>
          <cx:pt idx="1">oil sham</cx:pt>
          <cx:pt idx="2">oil sham</cx:pt>
          <cx:pt idx="3">oil sham</cx:pt>
          <cx:pt idx="4">oil sham</cx:pt>
          <cx:pt idx="5">oil sham</cx:pt>
          <cx:pt idx="6">oil sham</cx:pt>
          <cx:pt idx="7">oil sham</cx:pt>
          <cx:pt idx="8">oil sham</cx:pt>
          <cx:pt idx="9">oil sham</cx:pt>
          <cx:pt idx="10">oil sham</cx:pt>
          <cx:pt idx="11">oil sham</cx:pt>
          <cx:pt idx="12">n-3 PUFA sham</cx:pt>
          <cx:pt idx="13">n-3 PUFA sham</cx:pt>
          <cx:pt idx="14">n-3 PUFA sham</cx:pt>
          <cx:pt idx="15">n-3 PUFA sham</cx:pt>
          <cx:pt idx="16">n-3 PUFA sham</cx:pt>
          <cx:pt idx="17">n-3 PUFA sham</cx:pt>
          <cx:pt idx="18">n-3 PUFA sham</cx:pt>
          <cx:pt idx="19">n-3 PUFA sham</cx:pt>
          <cx:pt idx="20">n-3 PUFA sham</cx:pt>
          <cx:pt idx="21">n-3 PUFA sham</cx:pt>
          <cx:pt idx="22">oil sap</cx:pt>
          <cx:pt idx="23">oil sap</cx:pt>
          <cx:pt idx="24">oil sap</cx:pt>
          <cx:pt idx="25">oil sap</cx:pt>
          <cx:pt idx="26">oil sap</cx:pt>
          <cx:pt idx="27">oil sap</cx:pt>
          <cx:pt idx="28">oil sap</cx:pt>
          <cx:pt idx="29">oil sap</cx:pt>
          <cx:pt idx="30">oil sap</cx:pt>
          <cx:pt idx="31">oil sap</cx:pt>
          <cx:pt idx="32">n-3 PUFA sap</cx:pt>
          <cx:pt idx="33">n-3 PUFA sap</cx:pt>
          <cx:pt idx="34">n-3 PUFA sap</cx:pt>
          <cx:pt idx="35">n-3 PUFA sap</cx:pt>
          <cx:pt idx="36">n-3 PUFA sap</cx:pt>
          <cx:pt idx="37">n-3 PUFA sap</cx:pt>
          <cx:pt idx="38">n-3 PUFA sap</cx:pt>
          <cx:pt idx="39">n-3 PUFA sap</cx:pt>
          <cx:pt idx="40">n-3 PUFA sap</cx:pt>
          <cx:pt idx="41">n-3 PUFA sap</cx:pt>
        </cx:lvl>
      </cx:strDim>
      <cx:numDim type="val">
        <cx:f>'figure definitive'!$E$2:$E$43</cx:f>
        <cx:lvl ptCount="42" formatCode="Standard">
          <cx:pt idx="0">203</cx:pt>
          <cx:pt idx="1">256</cx:pt>
          <cx:pt idx="2">207</cx:pt>
          <cx:pt idx="3">213</cx:pt>
          <cx:pt idx="4">285</cx:pt>
          <cx:pt idx="5">217</cx:pt>
          <cx:pt idx="6">236</cx:pt>
          <cx:pt idx="7">234</cx:pt>
          <cx:pt idx="8">245</cx:pt>
          <cx:pt idx="9">264</cx:pt>
          <cx:pt idx="10">177</cx:pt>
          <cx:pt idx="11">230</cx:pt>
          <cx:pt idx="12">255</cx:pt>
          <cx:pt idx="13">249</cx:pt>
          <cx:pt idx="14">267</cx:pt>
          <cx:pt idx="15">263</cx:pt>
          <cx:pt idx="16">305</cx:pt>
          <cx:pt idx="17">226</cx:pt>
          <cx:pt idx="18">287</cx:pt>
          <cx:pt idx="19">265</cx:pt>
          <cx:pt idx="20">283</cx:pt>
          <cx:pt idx="21">253</cx:pt>
          <cx:pt idx="22">218</cx:pt>
          <cx:pt idx="23">199</cx:pt>
          <cx:pt idx="24">180</cx:pt>
          <cx:pt idx="25">169</cx:pt>
          <cx:pt idx="26">300</cx:pt>
          <cx:pt idx="27">363</cx:pt>
          <cx:pt idx="28">361</cx:pt>
          <cx:pt idx="29">264</cx:pt>
          <cx:pt idx="30">403</cx:pt>
          <cx:pt idx="31">175</cx:pt>
          <cx:pt idx="32">225</cx:pt>
          <cx:pt idx="33">159</cx:pt>
          <cx:pt idx="34">260</cx:pt>
          <cx:pt idx="35">243</cx:pt>
          <cx:pt idx="36">369</cx:pt>
          <cx:pt idx="37">409</cx:pt>
          <cx:pt idx="38">340</cx:pt>
          <cx:pt idx="39">345</cx:pt>
          <cx:pt idx="40">288</cx:pt>
          <cx:pt idx="41">407</cx:pt>
        </cx:lvl>
      </cx:numDim>
    </cx:data>
  </cx:chartData>
  <cx:chart>
    <cx:title pos="t" align="ctr" overlay="0">
      <cx:tx>
        <cx:txData>
          <cx:v>Frequency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/>
          </a:pPr>
          <a:r>
            <a:rPr lang="it-IT" sz="1400" b="0" i="0" u="none" strike="noStrike" baseline="0">
              <a:solidFill>
                <a:sysClr val="windowText" lastClr="000000">
                  <a:lumMod val="65000"/>
                  <a:lumOff val="35000"/>
                </a:sysClr>
              </a:solidFill>
              <a:latin typeface="Calibri" panose="020F0502020204030204"/>
            </a:rPr>
            <a:t>Frequency</a:t>
          </a:r>
        </a:p>
      </cx:txPr>
    </cx:title>
    <cx:plotArea>
      <cx:plotAreaRegion>
        <cx:series layoutId="boxWhisker" uniqueId="{6F5124A2-CDD5-4DBB-8DD9-BFB4A7F07590}">
          <cx:dataId val="0"/>
          <cx:layoutPr>
            <cx:statistics quartileMethod="exclusive"/>
          </cx:layoutPr>
        </cx:series>
      </cx:plotAreaRegion>
      <cx:axis id="0">
        <cx:catScaling gapWidth="1"/>
        <cx:tickLabels/>
      </cx:axis>
      <cx:axis id="1">
        <cx:valScaling/>
        <cx:majorGridlines/>
        <cx:tickLabels/>
      </cx:axis>
    </cx:plotArea>
  </cx:chart>
</cx:chartSpace>
</file>

<file path=ppt/charts/chartEx7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figura!$E$2:$E$39</cx:f>
        <cx:lvl ptCount="38">
          <cx:pt idx="0">oil sham</cx:pt>
          <cx:pt idx="1">oil sham</cx:pt>
          <cx:pt idx="2">oil sham</cx:pt>
          <cx:pt idx="3">oil sham</cx:pt>
          <cx:pt idx="4">oil sham</cx:pt>
          <cx:pt idx="5">oil sham</cx:pt>
          <cx:pt idx="6">oil sham</cx:pt>
          <cx:pt idx="7">oil sham</cx:pt>
          <cx:pt idx="8">oil sham</cx:pt>
          <cx:pt idx="9">oil sham</cx:pt>
          <cx:pt idx="10">oil sham</cx:pt>
          <cx:pt idx="11">oil sham</cx:pt>
          <cx:pt idx="12">n-3 PUFA sham</cx:pt>
          <cx:pt idx="13">n-3 PUFA sham</cx:pt>
          <cx:pt idx="14">n-3 PUFA sham</cx:pt>
          <cx:pt idx="15">n-3 PUFA sham</cx:pt>
          <cx:pt idx="16">n-3 PUFA sham</cx:pt>
          <cx:pt idx="17">n-3 PUFA sham</cx:pt>
          <cx:pt idx="18">n-3 PUFA sham</cx:pt>
          <cx:pt idx="19">n-3 PUFA sham</cx:pt>
          <cx:pt idx="20">n-3 PUFA sham</cx:pt>
          <cx:pt idx="21">oil sap</cx:pt>
          <cx:pt idx="22">oil sap</cx:pt>
          <cx:pt idx="23">oil sap</cx:pt>
          <cx:pt idx="24">oil sap</cx:pt>
          <cx:pt idx="25">oil sap</cx:pt>
          <cx:pt idx="26">oil sap</cx:pt>
          <cx:pt idx="27">oil sap</cx:pt>
          <cx:pt idx="28">oil sap</cx:pt>
          <cx:pt idx="29">oil sap</cx:pt>
          <cx:pt idx="30">n-3 PUFA sap</cx:pt>
          <cx:pt idx="31">n-3 PUFA sap</cx:pt>
          <cx:pt idx="32">n-3 PUFA sap</cx:pt>
          <cx:pt idx="33">n-3 PUFA sap</cx:pt>
          <cx:pt idx="34">n-3 PUFA sap</cx:pt>
          <cx:pt idx="35">n-3 PUFA sap</cx:pt>
          <cx:pt idx="36">n-3 PUFA sap</cx:pt>
          <cx:pt idx="37">n-3 PUFA sap</cx:pt>
        </cx:lvl>
      </cx:strDim>
      <cx:numDim type="val">
        <cx:f>figura!$F$2:$F$39</cx:f>
        <cx:lvl ptCount="38" formatCode="Standard">
          <cx:pt idx="0">140.5</cx:pt>
          <cx:pt idx="1">5.5</cx:pt>
          <cx:pt idx="2">95.5</cx:pt>
          <cx:pt idx="3">309.5</cx:pt>
          <cx:pt idx="4">292.5</cx:pt>
          <cx:pt idx="5">24</cx:pt>
          <cx:pt idx="6">10</cx:pt>
          <cx:pt idx="7">44</cx:pt>
          <cx:pt idx="8">9</cx:pt>
          <cx:pt idx="9">10</cx:pt>
          <cx:pt idx="10">16</cx:pt>
          <cx:pt idx="11">32</cx:pt>
          <cx:pt idx="12">20.5</cx:pt>
          <cx:pt idx="13">172.5</cx:pt>
          <cx:pt idx="14">261.5</cx:pt>
          <cx:pt idx="15">17.5</cx:pt>
          <cx:pt idx="16">6.5</cx:pt>
          <cx:pt idx="17">65</cx:pt>
          <cx:pt idx="18">86</cx:pt>
          <cx:pt idx="19">115</cx:pt>
          <cx:pt idx="20">40.5</cx:pt>
          <cx:pt idx="21">21.5</cx:pt>
          <cx:pt idx="22">25.5</cx:pt>
          <cx:pt idx="23">30.5</cx:pt>
          <cx:pt idx="24">39.5</cx:pt>
          <cx:pt idx="25">149.5</cx:pt>
          <cx:pt idx="26">143</cx:pt>
          <cx:pt idx="27">60</cx:pt>
          <cx:pt idx="28">194</cx:pt>
          <cx:pt idx="29">277</cx:pt>
          <cx:pt idx="30">58.5</cx:pt>
          <cx:pt idx="31">46.5</cx:pt>
          <cx:pt idx="32">20.5</cx:pt>
          <cx:pt idx="33">152.5</cx:pt>
          <cx:pt idx="34">119.5</cx:pt>
          <cx:pt idx="35">114.5</cx:pt>
          <cx:pt idx="36">48</cx:pt>
          <cx:pt idx="37">481.5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/>
            </a:pPr>
            <a:r>
              <a:rPr lang="it-IT" sz="1400" b="0" i="0" u="none" strike="noStrike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Calibri" panose="020F0502020204030204"/>
              </a:rPr>
              <a:t>Latency (s) </a:t>
            </a:r>
            <a:r>
              <a:rPr lang="en-US" sz="1400" b="0" i="0" u="none" strike="noStrike" baseline="0">
                <a:solidFill>
                  <a:sysClr val="windowText" lastClr="000000">
                    <a:lumMod val="65000"/>
                    <a:lumOff val="35000"/>
                  </a:sysClr>
                </a:solidFill>
                <a:effectLst/>
                <a:latin typeface="Calibri" panose="020F0502020204030204"/>
                <a:ea typeface="Calibri" panose="020F0502020204030204" pitchFamily="34" charset="0"/>
                <a:cs typeface="Calibri" panose="020F0502020204030204" pitchFamily="34" charset="0"/>
              </a:rPr>
              <a:t>to dig out and eat the palatable food pellet </a:t>
            </a:r>
            <a:endParaRPr lang="it-IT" sz="1400" b="0" i="0" u="none" strike="noStrike" baseline="0">
              <a:solidFill>
                <a:sysClr val="windowText" lastClr="000000">
                  <a:lumMod val="65000"/>
                  <a:lumOff val="35000"/>
                </a:sysClr>
              </a:solidFill>
              <a:latin typeface="Calibri" panose="020F0502020204030204"/>
            </a:endParaRPr>
          </a:p>
        </cx:rich>
      </cx:tx>
    </cx:title>
    <cx:plotArea>
      <cx:plotAreaRegion>
        <cx:series layoutId="boxWhisker" uniqueId="{C6A23CB7-22E5-439A-A6B8-1A802447F92C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ckLabels/>
      </cx:axis>
      <cx:axis id="1">
        <cx:valScaling/>
        <cx:majorGridlines/>
        <cx:tickLabels/>
      </cx:axis>
    </cx:plotArea>
  </cx:chart>
</cx:chartSpace>
</file>

<file path=ppt/charts/chartEx8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figure!$AB$1:$AB$41</cx:f>
        <cx:lvl ptCount="41">
          <cx:pt idx="0">oil sham</cx:pt>
          <cx:pt idx="1">oil sham</cx:pt>
          <cx:pt idx="2">oil sham</cx:pt>
          <cx:pt idx="3">oil sham</cx:pt>
          <cx:pt idx="4">oil sham</cx:pt>
          <cx:pt idx="5">oil sham</cx:pt>
          <cx:pt idx="6">oil sham</cx:pt>
          <cx:pt idx="7">oil sham</cx:pt>
          <cx:pt idx="8">oil sham</cx:pt>
          <cx:pt idx="9">oil sham</cx:pt>
          <cx:pt idx="10">oil sham</cx:pt>
          <cx:pt idx="11">n-3 PUFA sham</cx:pt>
          <cx:pt idx="12">n-3 PUFA sham</cx:pt>
          <cx:pt idx="13">n-3 PUFA sham</cx:pt>
          <cx:pt idx="14">n-3 PUFA sham</cx:pt>
          <cx:pt idx="15">n-3 PUFA sham</cx:pt>
          <cx:pt idx="16">n-3 PUFA sham</cx:pt>
          <cx:pt idx="17">n-3 PUFA sham</cx:pt>
          <cx:pt idx="18">n-3 PUFA sham</cx:pt>
          <cx:pt idx="19">n-3 PUFA sham</cx:pt>
          <cx:pt idx="20">n-3 PUFA sham</cx:pt>
          <cx:pt idx="21">oil sap</cx:pt>
          <cx:pt idx="22">oil sap</cx:pt>
          <cx:pt idx="23">oil sap</cx:pt>
          <cx:pt idx="24">oil sap</cx:pt>
          <cx:pt idx="25">oil sap</cx:pt>
          <cx:pt idx="26">oil sap</cx:pt>
          <cx:pt idx="27">oil sap</cx:pt>
          <cx:pt idx="28">oil sap</cx:pt>
          <cx:pt idx="29">oil sap</cx:pt>
          <cx:pt idx="30">oil sap</cx:pt>
          <cx:pt idx="31">n-3 PUFA sap</cx:pt>
          <cx:pt idx="32">n-3 PUFA sap</cx:pt>
          <cx:pt idx="33">n-3 PUFA sap</cx:pt>
          <cx:pt idx="34">n-3 PUFA sap</cx:pt>
          <cx:pt idx="35">n-3 PUFA sap</cx:pt>
          <cx:pt idx="36">n-3 PUFA sap</cx:pt>
          <cx:pt idx="37">n-3 PUFA sap</cx:pt>
          <cx:pt idx="38">n-3 PUFA sap</cx:pt>
          <cx:pt idx="39">n-3 PUFA sap</cx:pt>
          <cx:pt idx="40">n-3 PUFA sap</cx:pt>
        </cx:lvl>
      </cx:strDim>
      <cx:numDim type="val">
        <cx:f>figure!$AC$1:$AC$41</cx:f>
        <cx:lvl ptCount="41" formatCode="Standard">
          <cx:pt idx="0">19.579999999999998</cx:pt>
          <cx:pt idx="1">2.27</cx:pt>
          <cx:pt idx="2">6.1100000000000003</cx:pt>
          <cx:pt idx="3">14.57</cx:pt>
          <cx:pt idx="4">3.1699999999999999</cx:pt>
          <cx:pt idx="5">13.07</cx:pt>
          <cx:pt idx="6">33</cx:pt>
          <cx:pt idx="7">55</cx:pt>
          <cx:pt idx="8">5</cx:pt>
          <cx:pt idx="9">40</cx:pt>
          <cx:pt idx="10">19.177</cx:pt>
          <cx:pt idx="11">5.4400000000000004</cx:pt>
          <cx:pt idx="12">1.1699999999999999</cx:pt>
          <cx:pt idx="13">13.35</cx:pt>
          <cx:pt idx="14">4.1900000000000004</cx:pt>
          <cx:pt idx="15">18</cx:pt>
          <cx:pt idx="16">64</cx:pt>
          <cx:pt idx="17">85</cx:pt>
          <cx:pt idx="18">63</cx:pt>
          <cx:pt idx="19">51</cx:pt>
          <cx:pt idx="20">33.905555555555551</cx:pt>
          <cx:pt idx="21">6.4299999999999997</cx:pt>
          <cx:pt idx="22">5.5499999999999998</cx:pt>
          <cx:pt idx="23">1.48</cx:pt>
          <cx:pt idx="24">3.3599999999999999</cx:pt>
          <cx:pt idx="25">4.3499999999999996</cx:pt>
          <cx:pt idx="26">17</cx:pt>
          <cx:pt idx="27">61</cx:pt>
          <cx:pt idx="28">14.167142857142858</cx:pt>
          <cx:pt idx="29">14.167142857142858</cx:pt>
          <cx:pt idx="30">14.167142857142858</cx:pt>
          <cx:pt idx="31">6.0199999999999996</cx:pt>
          <cx:pt idx="32">6.7999999999999998</cx:pt>
          <cx:pt idx="33">2.9300000000000002</cx:pt>
          <cx:pt idx="34">4.9400000000000004</cx:pt>
          <cx:pt idx="35">1.3</cx:pt>
          <cx:pt idx="36">0.53000000000000003</cx:pt>
          <cx:pt idx="37">17</cx:pt>
          <cx:pt idx="38">10</cx:pt>
          <cx:pt idx="39">54</cx:pt>
          <cx:pt idx="40">28</cx:pt>
        </cx:lvl>
      </cx:numDim>
    </cx:data>
  </cx:chartData>
  <cx:chart>
    <cx:title pos="t" align="ctr" overlay="0">
      <cx:tx>
        <cx:txData>
          <cx:v>Freezing duration (s)</cx:v>
        </cx:txData>
      </cx:tx>
      <cx:txPr>
        <a:bodyPr spcFirstLastPara="1" vertOverflow="ellipsis" horzOverflow="overflow" wrap="square" lIns="0" tIns="0" rIns="0" bIns="0" anchor="ctr" anchorCtr="1"/>
        <a:lstStyle/>
        <a:p>
          <a:pPr algn="ctr" rtl="0">
            <a:defRPr/>
          </a:pPr>
          <a:r>
            <a:rPr lang="it-IT" sz="1400" b="0" i="0" u="none" strike="noStrike" baseline="0">
              <a:solidFill>
                <a:sysClr val="windowText" lastClr="000000">
                  <a:lumMod val="65000"/>
                  <a:lumOff val="35000"/>
                </a:sysClr>
              </a:solidFill>
              <a:latin typeface="Calibri" panose="020F0502020204030204"/>
            </a:rPr>
            <a:t>Freezing duration (s)</a:t>
          </a:r>
        </a:p>
      </cx:txPr>
    </cx:title>
    <cx:plotArea>
      <cx:plotAreaRegion>
        <cx:series layoutId="boxWhisker" uniqueId="{49403577-CD6B-4807-9124-0DD0E3E01334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ckLabels/>
      </cx:axis>
      <cx:axis id="1">
        <cx:valScaling/>
        <cx:majorGridlines/>
        <cx:tickLabels/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85020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7370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275334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3760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8486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0477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10492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3695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6972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612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5080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9EB10-68AB-4B04-9152-56C9ECD0A2B5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AC8E2-2126-46ED-9CA4-D1A60DED142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0813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microsoft.com/office/2014/relationships/chartEx" Target="../charts/chartEx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png"/><Relationship Id="rId4" Type="http://schemas.microsoft.com/office/2014/relationships/chartEx" Target="../charts/chartEx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microsoft.com/office/2014/relationships/chartEx" Target="../charts/chartEx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microsoft.com/office/2014/relationships/chartEx" Target="../charts/chartEx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microsoft.com/office/2014/relationships/chartEx" Target="../charts/chartEx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microsoft.com/office/2014/relationships/chartEx" Target="../charts/chartEx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microsoft.com/office/2014/relationships/chartEx" Target="../charts/chartEx7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microsoft.com/office/2014/relationships/chartEx" Target="../charts/chartEx8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65FB2A5A-9812-4F1A-86AF-B9D7240FFC60}"/>
              </a:ext>
            </a:extLst>
          </p:cNvPr>
          <p:cNvSpPr txBox="1"/>
          <p:nvPr/>
        </p:nvSpPr>
        <p:spPr>
          <a:xfrm>
            <a:off x="1946304" y="320145"/>
            <a:ext cx="29653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Suppl. Fig. 1. Splash Test (ST)</a:t>
            </a: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4" name="Grafico 13">
                <a:extLst>
                  <a:ext uri="{FF2B5EF4-FFF2-40B4-BE49-F238E27FC236}">
                    <a16:creationId xmlns:a16="http://schemas.microsoft.com/office/drawing/2014/main" id="{4B07C1E4-0861-40E5-9DD7-B0FBC4E10C3B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681232912"/>
                  </p:ext>
                </p:extLst>
              </p:nvPr>
            </p:nvGraphicFramePr>
            <p:xfrm>
              <a:off x="1143000" y="1083856"/>
              <a:ext cx="4572000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14" name="Grafico 13">
                <a:extLst>
                  <a:ext uri="{FF2B5EF4-FFF2-40B4-BE49-F238E27FC236}">
                    <a16:creationId xmlns:a16="http://schemas.microsoft.com/office/drawing/2014/main" id="{4B07C1E4-0861-40E5-9DD7-B0FBC4E10C3B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43000" y="1083856"/>
                <a:ext cx="4572000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6" name="Grafico 15">
                <a:extLst>
                  <a:ext uri="{FF2B5EF4-FFF2-40B4-BE49-F238E27FC236}">
                    <a16:creationId xmlns:a16="http://schemas.microsoft.com/office/drawing/2014/main" id="{60F7E969-2350-4D19-A86C-9F52C241FE8D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110718169"/>
                  </p:ext>
                </p:extLst>
              </p:nvPr>
            </p:nvGraphicFramePr>
            <p:xfrm>
              <a:off x="1143000" y="4221435"/>
              <a:ext cx="4572000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4"/>
              </a:graphicData>
            </a:graphic>
          </p:graphicFrame>
        </mc:Choice>
        <mc:Fallback xmlns="">
          <p:pic>
            <p:nvPicPr>
              <p:cNvPr id="16" name="Grafico 15">
                <a:extLst>
                  <a:ext uri="{FF2B5EF4-FFF2-40B4-BE49-F238E27FC236}">
                    <a16:creationId xmlns:a16="http://schemas.microsoft.com/office/drawing/2014/main" id="{60F7E969-2350-4D19-A86C-9F52C241FE8D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143000" y="4221435"/>
                <a:ext cx="4572000" cy="2743200"/>
              </a:xfrm>
              <a:prstGeom prst="rect">
                <a:avLst/>
              </a:prstGeom>
            </p:spPr>
          </p:pic>
        </mc:Fallback>
      </mc:AlternateContent>
      <p:sp>
        <p:nvSpPr>
          <p:cNvPr id="6" name="Rettangolo 5">
            <a:extLst>
              <a:ext uri="{FF2B5EF4-FFF2-40B4-BE49-F238E27FC236}">
                <a16:creationId xmlns:a16="http://schemas.microsoft.com/office/drawing/2014/main" id="{A69482F6-676F-4B98-9929-6839462B944B}"/>
              </a:ext>
            </a:extLst>
          </p:cNvPr>
          <p:cNvSpPr/>
          <p:nvPr/>
        </p:nvSpPr>
        <p:spPr>
          <a:xfrm>
            <a:off x="81442" y="7411251"/>
            <a:ext cx="669511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. 1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uration (s) and frequency of grooming observed in the four experimental groups during ST. 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223456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A9A381F1-4D5A-448F-8D50-A1F0CE1BD883}"/>
              </a:ext>
            </a:extLst>
          </p:cNvPr>
          <p:cNvSpPr txBox="1"/>
          <p:nvPr/>
        </p:nvSpPr>
        <p:spPr>
          <a:xfrm>
            <a:off x="1338797" y="363363"/>
            <a:ext cx="4180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Suppl. Fig. 2A. Social Interactions (SI)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16954833-9A41-40D4-98B9-470DB07A5254}"/>
              </a:ext>
            </a:extLst>
          </p:cNvPr>
          <p:cNvSpPr txBox="1"/>
          <p:nvPr/>
        </p:nvSpPr>
        <p:spPr>
          <a:xfrm>
            <a:off x="1961087" y="1157209"/>
            <a:ext cx="2935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Social </a:t>
            </a:r>
            <a:r>
              <a:rPr lang="it-IT" b="1" dirty="0" err="1"/>
              <a:t>behaviors</a:t>
            </a:r>
            <a:endParaRPr lang="it-IT" b="1" dirty="0"/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4" name="Grafico 3">
                <a:extLst>
                  <a:ext uri="{FF2B5EF4-FFF2-40B4-BE49-F238E27FC236}">
                    <a16:creationId xmlns:a16="http://schemas.microsoft.com/office/drawing/2014/main" id="{D43E5C9B-B856-4E0F-A274-74A1FD1E94AA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312526576"/>
                  </p:ext>
                </p:extLst>
              </p:nvPr>
            </p:nvGraphicFramePr>
            <p:xfrm>
              <a:off x="1143000" y="1897380"/>
              <a:ext cx="4572000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4" name="Grafico 3">
                <a:extLst>
                  <a:ext uri="{FF2B5EF4-FFF2-40B4-BE49-F238E27FC236}">
                    <a16:creationId xmlns:a16="http://schemas.microsoft.com/office/drawing/2014/main" id="{D43E5C9B-B856-4E0F-A274-74A1FD1E94AA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43000" y="1897380"/>
                <a:ext cx="4572000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5" name="Grafico 4">
                <a:extLst>
                  <a:ext uri="{FF2B5EF4-FFF2-40B4-BE49-F238E27FC236}">
                    <a16:creationId xmlns:a16="http://schemas.microsoft.com/office/drawing/2014/main" id="{2141B783-C1D3-4F13-B223-DD0C02C1775C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594554259"/>
                  </p:ext>
                </p:extLst>
              </p:nvPr>
            </p:nvGraphicFramePr>
            <p:xfrm>
              <a:off x="1143000" y="5265420"/>
              <a:ext cx="4572000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4"/>
              </a:graphicData>
            </a:graphic>
          </p:graphicFrame>
        </mc:Choice>
        <mc:Fallback xmlns="">
          <p:pic>
            <p:nvPicPr>
              <p:cNvPr id="5" name="Grafico 4">
                <a:extLst>
                  <a:ext uri="{FF2B5EF4-FFF2-40B4-BE49-F238E27FC236}">
                    <a16:creationId xmlns:a16="http://schemas.microsoft.com/office/drawing/2014/main" id="{2141B783-C1D3-4F13-B223-DD0C02C1775C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143000" y="5265420"/>
                <a:ext cx="4572000" cy="2743200"/>
              </a:xfrm>
              <a:prstGeom prst="rect">
                <a:avLst/>
              </a:prstGeom>
            </p:spPr>
          </p:pic>
        </mc:Fallback>
      </mc:AlternateContent>
      <p:sp>
        <p:nvSpPr>
          <p:cNvPr id="6" name="Rettangolo 5">
            <a:extLst>
              <a:ext uri="{FF2B5EF4-FFF2-40B4-BE49-F238E27FC236}">
                <a16:creationId xmlns:a16="http://schemas.microsoft.com/office/drawing/2014/main" id="{0C2EDF0B-585F-4C04-AD9F-2B3D835CA546}"/>
              </a:ext>
            </a:extLst>
          </p:cNvPr>
          <p:cNvSpPr/>
          <p:nvPr/>
        </p:nvSpPr>
        <p:spPr>
          <a:xfrm>
            <a:off x="81442" y="8475783"/>
            <a:ext cx="669511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. 2A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uration (s) and frequency of social behaviors observed in the four experimental groups during SI. 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20642648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A9A381F1-4D5A-448F-8D50-A1F0CE1BD883}"/>
              </a:ext>
            </a:extLst>
          </p:cNvPr>
          <p:cNvSpPr txBox="1"/>
          <p:nvPr/>
        </p:nvSpPr>
        <p:spPr>
          <a:xfrm>
            <a:off x="1447980" y="363362"/>
            <a:ext cx="3962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Suppl. Fig. 2B. Social Interactions (SI)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16954833-9A41-40D4-98B9-470DB07A5254}"/>
              </a:ext>
            </a:extLst>
          </p:cNvPr>
          <p:cNvSpPr txBox="1"/>
          <p:nvPr/>
        </p:nvSpPr>
        <p:spPr>
          <a:xfrm>
            <a:off x="1961087" y="1129913"/>
            <a:ext cx="2935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Non-social </a:t>
            </a:r>
            <a:r>
              <a:rPr lang="it-IT" b="1" dirty="0" err="1"/>
              <a:t>behaviors</a:t>
            </a:r>
            <a:endParaRPr lang="it-IT" b="1" dirty="0"/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6" name="Grafico 5">
                <a:extLst>
                  <a:ext uri="{FF2B5EF4-FFF2-40B4-BE49-F238E27FC236}">
                    <a16:creationId xmlns:a16="http://schemas.microsoft.com/office/drawing/2014/main" id="{9686615A-3578-4612-8C55-B4EDA8B7F8FC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924896846"/>
                  </p:ext>
                </p:extLst>
              </p:nvPr>
            </p:nvGraphicFramePr>
            <p:xfrm>
              <a:off x="1143000" y="1897607"/>
              <a:ext cx="4572000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6" name="Grafico 5">
                <a:extLst>
                  <a:ext uri="{FF2B5EF4-FFF2-40B4-BE49-F238E27FC236}">
                    <a16:creationId xmlns:a16="http://schemas.microsoft.com/office/drawing/2014/main" id="{9686615A-3578-4612-8C55-B4EDA8B7F8FC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43000" y="1897607"/>
                <a:ext cx="4572000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7" name="Grafico 6">
                <a:extLst>
                  <a:ext uri="{FF2B5EF4-FFF2-40B4-BE49-F238E27FC236}">
                    <a16:creationId xmlns:a16="http://schemas.microsoft.com/office/drawing/2014/main" id="{F0C4E4B0-BE6C-4717-B091-839512060146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576944851"/>
                  </p:ext>
                </p:extLst>
              </p:nvPr>
            </p:nvGraphicFramePr>
            <p:xfrm>
              <a:off x="1143000" y="5180465"/>
              <a:ext cx="4572000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4"/>
              </a:graphicData>
            </a:graphic>
          </p:graphicFrame>
        </mc:Choice>
        <mc:Fallback xmlns="">
          <p:pic>
            <p:nvPicPr>
              <p:cNvPr id="7" name="Grafico 6">
                <a:extLst>
                  <a:ext uri="{FF2B5EF4-FFF2-40B4-BE49-F238E27FC236}">
                    <a16:creationId xmlns:a16="http://schemas.microsoft.com/office/drawing/2014/main" id="{F0C4E4B0-BE6C-4717-B091-839512060146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143000" y="5180465"/>
                <a:ext cx="4572000" cy="2743200"/>
              </a:xfrm>
              <a:prstGeom prst="rect">
                <a:avLst/>
              </a:prstGeom>
            </p:spPr>
          </p:pic>
        </mc:Fallback>
      </mc:AlternateContent>
      <p:sp>
        <p:nvSpPr>
          <p:cNvPr id="8" name="Rettangolo 7">
            <a:extLst>
              <a:ext uri="{FF2B5EF4-FFF2-40B4-BE49-F238E27FC236}">
                <a16:creationId xmlns:a16="http://schemas.microsoft.com/office/drawing/2014/main" id="{69258273-CDD1-49FE-AC87-4C84C9CE8544}"/>
              </a:ext>
            </a:extLst>
          </p:cNvPr>
          <p:cNvSpPr/>
          <p:nvPr/>
        </p:nvSpPr>
        <p:spPr>
          <a:xfrm>
            <a:off x="81442" y="8489085"/>
            <a:ext cx="6695116" cy="6330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. 2B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uration (s) and frequency of non-social behaviors observed in the four experimental groups during SI. 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26434172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86508EE8-9D5D-4434-AE43-C752BEE435C9}"/>
              </a:ext>
            </a:extLst>
          </p:cNvPr>
          <p:cNvSpPr txBox="1"/>
          <p:nvPr/>
        </p:nvSpPr>
        <p:spPr>
          <a:xfrm>
            <a:off x="1342210" y="527138"/>
            <a:ext cx="41735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Suppl. Fig.3. </a:t>
            </a:r>
            <a:r>
              <a:rPr lang="it-IT" b="1" dirty="0" err="1"/>
              <a:t>Hidden</a:t>
            </a:r>
            <a:r>
              <a:rPr lang="it-IT" b="1" dirty="0"/>
              <a:t> Food Test (HFT)</a:t>
            </a: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1" name="Grafico 20">
                <a:extLst>
                  <a:ext uri="{FF2B5EF4-FFF2-40B4-BE49-F238E27FC236}">
                    <a16:creationId xmlns:a16="http://schemas.microsoft.com/office/drawing/2014/main" id="{B77D82B7-39BA-4044-8150-D74082968CC3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241361306"/>
                  </p:ext>
                </p:extLst>
              </p:nvPr>
            </p:nvGraphicFramePr>
            <p:xfrm>
              <a:off x="1143000" y="1452351"/>
              <a:ext cx="4572000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21" name="Grafico 20">
                <a:extLst>
                  <a:ext uri="{FF2B5EF4-FFF2-40B4-BE49-F238E27FC236}">
                    <a16:creationId xmlns:a16="http://schemas.microsoft.com/office/drawing/2014/main" id="{B77D82B7-39BA-4044-8150-D74082968CC3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43000" y="1452351"/>
                <a:ext cx="4572000" cy="2743200"/>
              </a:xfrm>
              <a:prstGeom prst="rect">
                <a:avLst/>
              </a:prstGeom>
            </p:spPr>
          </p:pic>
        </mc:Fallback>
      </mc:AlternateContent>
      <p:sp>
        <p:nvSpPr>
          <p:cNvPr id="4" name="Rettangolo 3">
            <a:extLst>
              <a:ext uri="{FF2B5EF4-FFF2-40B4-BE49-F238E27FC236}">
                <a16:creationId xmlns:a16="http://schemas.microsoft.com/office/drawing/2014/main" id="{F62C9CF3-EDF5-45F2-BAD6-DF2BBE7BBEE4}"/>
              </a:ext>
            </a:extLst>
          </p:cNvPr>
          <p:cNvSpPr/>
          <p:nvPr/>
        </p:nvSpPr>
        <p:spPr>
          <a:xfrm>
            <a:off x="81442" y="4777236"/>
            <a:ext cx="669511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. 3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verage time (s) to dig out and eat the palatable food during HFT in the four experimental groups. 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9657398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86508EE8-9D5D-4434-AE43-C752BEE435C9}"/>
              </a:ext>
            </a:extLst>
          </p:cNvPr>
          <p:cNvSpPr txBox="1"/>
          <p:nvPr/>
        </p:nvSpPr>
        <p:spPr>
          <a:xfrm>
            <a:off x="725038" y="527133"/>
            <a:ext cx="540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Suppl. Fig. 4. Predator </a:t>
            </a:r>
            <a:r>
              <a:rPr lang="it-IT" b="1" dirty="0" err="1"/>
              <a:t>Odor</a:t>
            </a:r>
            <a:r>
              <a:rPr lang="it-IT" b="1" dirty="0"/>
              <a:t> </a:t>
            </a:r>
            <a:r>
              <a:rPr lang="it-IT" b="1" dirty="0" err="1"/>
              <a:t>Fear</a:t>
            </a:r>
            <a:r>
              <a:rPr lang="it-IT" b="1" dirty="0"/>
              <a:t> </a:t>
            </a:r>
            <a:r>
              <a:rPr lang="it-IT" b="1" dirty="0" err="1"/>
              <a:t>Conditioning</a:t>
            </a:r>
            <a:r>
              <a:rPr lang="it-IT" b="1" dirty="0"/>
              <a:t> (POFC)</a:t>
            </a: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9" name="Grafico 18">
                <a:extLst>
                  <a:ext uri="{FF2B5EF4-FFF2-40B4-BE49-F238E27FC236}">
                    <a16:creationId xmlns:a16="http://schemas.microsoft.com/office/drawing/2014/main" id="{DB83B9F7-19CC-4AC4-AA12-08E347A37AB8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536209099"/>
                  </p:ext>
                </p:extLst>
              </p:nvPr>
            </p:nvGraphicFramePr>
            <p:xfrm>
              <a:off x="1143000" y="1438698"/>
              <a:ext cx="4572000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19" name="Grafico 18">
                <a:extLst>
                  <a:ext uri="{FF2B5EF4-FFF2-40B4-BE49-F238E27FC236}">
                    <a16:creationId xmlns:a16="http://schemas.microsoft.com/office/drawing/2014/main" id="{DB83B9F7-19CC-4AC4-AA12-08E347A37AB8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43000" y="1438698"/>
                <a:ext cx="4572000" cy="2743200"/>
              </a:xfrm>
              <a:prstGeom prst="rect">
                <a:avLst/>
              </a:prstGeom>
            </p:spPr>
          </p:pic>
        </mc:Fallback>
      </mc:AlternateContent>
      <p:sp>
        <p:nvSpPr>
          <p:cNvPr id="4" name="Rettangolo 3">
            <a:extLst>
              <a:ext uri="{FF2B5EF4-FFF2-40B4-BE49-F238E27FC236}">
                <a16:creationId xmlns:a16="http://schemas.microsoft.com/office/drawing/2014/main" id="{A062D87F-8389-4230-9D42-593F4D719B16}"/>
              </a:ext>
            </a:extLst>
          </p:cNvPr>
          <p:cNvSpPr/>
          <p:nvPr/>
        </p:nvSpPr>
        <p:spPr>
          <a:xfrm>
            <a:off x="81442" y="4736293"/>
            <a:ext cx="669511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. 4.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eezing time (s) during exposure session of POFC in the four experimental groups. 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5864125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86508EE8-9D5D-4434-AE43-C752BEE435C9}"/>
              </a:ext>
            </a:extLst>
          </p:cNvPr>
          <p:cNvSpPr txBox="1"/>
          <p:nvPr/>
        </p:nvSpPr>
        <p:spPr>
          <a:xfrm>
            <a:off x="725038" y="568076"/>
            <a:ext cx="540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Suppl. Fig. 5. </a:t>
            </a:r>
            <a:r>
              <a:rPr lang="it-IT" b="1" dirty="0" err="1"/>
              <a:t>ChAT</a:t>
            </a:r>
            <a:r>
              <a:rPr lang="it-IT" b="1" dirty="0"/>
              <a:t> </a:t>
            </a:r>
            <a:r>
              <a:rPr lang="it-IT" b="1" dirty="0" err="1"/>
              <a:t>immunofluorescence</a:t>
            </a:r>
            <a:endParaRPr lang="it-IT" b="1" dirty="0"/>
          </a:p>
        </p:txBody>
      </p:sp>
      <p:sp>
        <p:nvSpPr>
          <p:cNvPr id="3" name="Rettangolo 2">
            <a:extLst>
              <a:ext uri="{FF2B5EF4-FFF2-40B4-BE49-F238E27FC236}">
                <a16:creationId xmlns:a16="http://schemas.microsoft.com/office/drawing/2014/main" id="{39843CDA-8F3A-45B8-9918-528952BB0702}"/>
              </a:ext>
            </a:extLst>
          </p:cNvPr>
          <p:cNvSpPr/>
          <p:nvPr/>
        </p:nvSpPr>
        <p:spPr>
          <a:xfrm>
            <a:off x="81442" y="8857927"/>
            <a:ext cx="669511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Fig. 5.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focal images showing the </a:t>
            </a:r>
            <a:r>
              <a:rPr lang="it-IT" sz="1400" dirty="0" err="1"/>
              <a:t>Choline</a:t>
            </a:r>
            <a:r>
              <a:rPr lang="it-IT" sz="1400" dirty="0"/>
              <a:t> </a:t>
            </a:r>
            <a:r>
              <a:rPr lang="it-IT" sz="1400" dirty="0" err="1"/>
              <a:t>Acetyltransferase</a:t>
            </a:r>
            <a:r>
              <a:rPr lang="it-IT" sz="1400" dirty="0"/>
              <a:t> (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AT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red) immunostaining in the medial septum (MS) of saline (sham; A) and sap-lesioned mice (sap; B). Note the almost complete depletion of cholinergic neurons after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porin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jection compared with saline injection (sham). Scale bar: 100 </a:t>
            </a:r>
            <a:r>
              <a:rPr lang="en-US" sz="1400" dirty="0"/>
              <a:t>µm.</a:t>
            </a:r>
            <a:r>
              <a:rPr lang="it-IT" sz="1400" dirty="0"/>
              <a:t> </a:t>
            </a:r>
          </a:p>
        </p:txBody>
      </p:sp>
      <p:grpSp>
        <p:nvGrpSpPr>
          <p:cNvPr id="4" name="Gruppo 3">
            <a:extLst>
              <a:ext uri="{FF2B5EF4-FFF2-40B4-BE49-F238E27FC236}">
                <a16:creationId xmlns:a16="http://schemas.microsoft.com/office/drawing/2014/main" id="{8122A1FF-597D-472C-9DA1-A8FEDD3FB6F5}"/>
              </a:ext>
            </a:extLst>
          </p:cNvPr>
          <p:cNvGrpSpPr/>
          <p:nvPr/>
        </p:nvGrpSpPr>
        <p:grpSpPr>
          <a:xfrm>
            <a:off x="1629000" y="1039390"/>
            <a:ext cx="3600000" cy="7493381"/>
            <a:chOff x="239232" y="288759"/>
            <a:chExt cx="3600000" cy="7493381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1F516CF8-AADB-472F-937B-BC134414B76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9232" y="4182140"/>
              <a:ext cx="3600000" cy="3600000"/>
            </a:xfrm>
            <a:prstGeom prst="rect">
              <a:avLst/>
            </a:prstGeom>
          </p:spPr>
        </p:pic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5FB3D01C-11E4-4814-968D-01AA0ADA112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5162" y="297932"/>
              <a:ext cx="3574070" cy="3600000"/>
            </a:xfrm>
            <a:prstGeom prst="rect">
              <a:avLst/>
            </a:prstGeom>
            <a:ln w="31750">
              <a:solidFill>
                <a:schemeClr val="tx1"/>
              </a:solidFill>
            </a:ln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4D6F37CC-B2E9-44A1-A8ED-C8CB8935EFEC}"/>
                </a:ext>
              </a:extLst>
            </p:cNvPr>
            <p:cNvSpPr txBox="1"/>
            <p:nvPr/>
          </p:nvSpPr>
          <p:spPr>
            <a:xfrm>
              <a:off x="1716506" y="288759"/>
              <a:ext cx="7761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B8F11BFC-19DC-495C-B7CD-2EDD0D34DFB4}"/>
                </a:ext>
              </a:extLst>
            </p:cNvPr>
            <p:cNvSpPr txBox="1"/>
            <p:nvPr/>
          </p:nvSpPr>
          <p:spPr>
            <a:xfrm>
              <a:off x="1619247" y="4182140"/>
              <a:ext cx="593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P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50C359FF-F72A-4C88-B6F4-2C17E097E7D3}"/>
                </a:ext>
              </a:extLst>
            </p:cNvPr>
            <p:cNvSpPr txBox="1"/>
            <p:nvPr/>
          </p:nvSpPr>
          <p:spPr>
            <a:xfrm>
              <a:off x="1856568" y="1584222"/>
              <a:ext cx="4876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>
                  <a:solidFill>
                    <a:schemeClr val="bg1"/>
                  </a:solidFill>
                </a:rPr>
                <a:t>MS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D5487D3E-7D97-4FA7-8F5A-2D4B096BB86A}"/>
                </a:ext>
              </a:extLst>
            </p:cNvPr>
            <p:cNvSpPr txBox="1"/>
            <p:nvPr/>
          </p:nvSpPr>
          <p:spPr>
            <a:xfrm>
              <a:off x="1672146" y="5378055"/>
              <a:ext cx="4876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>
                  <a:solidFill>
                    <a:schemeClr val="bg1"/>
                  </a:solidFill>
                </a:rPr>
                <a:t>MS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B86352F8-4663-44AE-94B0-7A545A9B64E0}"/>
                </a:ext>
              </a:extLst>
            </p:cNvPr>
            <p:cNvSpPr txBox="1"/>
            <p:nvPr/>
          </p:nvSpPr>
          <p:spPr>
            <a:xfrm>
              <a:off x="304642" y="297932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90C2CD72-A939-4FEE-A8F2-035A4A442E8D}"/>
                </a:ext>
              </a:extLst>
            </p:cNvPr>
            <p:cNvSpPr txBox="1"/>
            <p:nvPr/>
          </p:nvSpPr>
          <p:spPr>
            <a:xfrm>
              <a:off x="305289" y="4248286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13" name="Connettore 1 16">
              <a:extLst>
                <a:ext uri="{FF2B5EF4-FFF2-40B4-BE49-F238E27FC236}">
                  <a16:creationId xmlns:a16="http://schemas.microsoft.com/office/drawing/2014/main" id="{2B422D95-215A-40AD-99E1-2E70DA19BEE2}"/>
                </a:ext>
              </a:extLst>
            </p:cNvPr>
            <p:cNvCxnSpPr/>
            <p:nvPr/>
          </p:nvCxnSpPr>
          <p:spPr>
            <a:xfrm>
              <a:off x="3322320" y="498884"/>
              <a:ext cx="324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0643217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ella 4">
            <a:extLst>
              <a:ext uri="{FF2B5EF4-FFF2-40B4-BE49-F238E27FC236}">
                <a16:creationId xmlns:a16="http://schemas.microsoft.com/office/drawing/2014/main" id="{9807A969-B1B6-4C17-915D-093FBD5D6E0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2422597"/>
              </p:ext>
            </p:extLst>
          </p:nvPr>
        </p:nvGraphicFramePr>
        <p:xfrm>
          <a:off x="1143000" y="1422779"/>
          <a:ext cx="4572000" cy="5588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2396944207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400111223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1630087524"/>
                    </a:ext>
                  </a:extLst>
                </a:gridCol>
              </a:tblGrid>
              <a:tr h="370840">
                <a:tc gridSpan="3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/>
                        <a:t>Social behaviors</a:t>
                      </a:r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b="1" i="1" dirty="0"/>
                        <a:t>Dur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b="1" i="1" dirty="0"/>
                        <a:t>Frequency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0662883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b="1" dirty="0"/>
                        <a:t>Sniff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/>
                        <a:t>H=1.09, p=0.7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/>
                        <a:t>H=4.19, p=0.2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265297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b="1" dirty="0" err="1"/>
                        <a:t>Allogrooming</a:t>
                      </a:r>
                      <a:endParaRPr lang="it-IT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0.76, p=0.8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0.48, p=0.9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0219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b="1" dirty="0" err="1"/>
                        <a:t>Crawling</a:t>
                      </a:r>
                      <a:r>
                        <a:rPr lang="it-IT" b="1" dirty="0"/>
                        <a:t> over</a:t>
                      </a:r>
                      <a:r>
                        <a:rPr lang="it-IT" b="1" baseline="0" dirty="0"/>
                        <a:t>/under</a:t>
                      </a:r>
                      <a:endParaRPr lang="it-IT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1.78, p=0.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1.61, p=0.6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38923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b="1" dirty="0"/>
                        <a:t>Social </a:t>
                      </a:r>
                      <a:r>
                        <a:rPr lang="it-IT" b="1" dirty="0" err="1"/>
                        <a:t>resting</a:t>
                      </a:r>
                      <a:endParaRPr lang="it-IT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2.69, p=0.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2.70, p=0.4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00449668"/>
                  </a:ext>
                </a:extLst>
              </a:tr>
              <a:tr h="370840">
                <a:tc gridSpan="3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350" b="1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Non-social behaviors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299887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b="1" i="1" dirty="0"/>
                        <a:t>Dur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b="1" i="1" dirty="0"/>
                        <a:t>Frequency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b="1" dirty="0" err="1"/>
                        <a:t>Wall-rearing</a:t>
                      </a:r>
                      <a:r>
                        <a:rPr lang="it-IT" b="1" dirty="0"/>
                        <a:t> and </a:t>
                      </a:r>
                      <a:r>
                        <a:rPr lang="it-IT" b="1" dirty="0" err="1"/>
                        <a:t>rearing</a:t>
                      </a:r>
                      <a:endParaRPr lang="it-IT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5.07, p=0.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8.07, p=0.0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344334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b="1" dirty="0"/>
                        <a:t>Explor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0.85, p=0.8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4.73, p=0.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17922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b="1" dirty="0" err="1"/>
                        <a:t>Jumping</a:t>
                      </a:r>
                      <a:endParaRPr lang="it-IT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2.26, p=0.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2.24, p=0.5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42086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b="1" dirty="0"/>
                        <a:t>Self-groom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0.32, p=0.9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0.35, p=0.95</a:t>
                      </a:r>
                    </a:p>
                    <a:p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5265477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b="1" dirty="0" err="1"/>
                        <a:t>Resting</a:t>
                      </a:r>
                      <a:r>
                        <a:rPr lang="it-IT" b="1" dirty="0"/>
                        <a:t> al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0.91, p=0.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1.39, p=0.7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07261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b="1" dirty="0" err="1"/>
                        <a:t>Immobility</a:t>
                      </a:r>
                      <a:r>
                        <a:rPr lang="it-IT" b="1" dirty="0"/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3.99, p=0.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/>
                        <a:t>H=2.63, p=0.4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3086623"/>
                  </a:ext>
                </a:extLst>
              </a:tr>
            </a:tbl>
          </a:graphicData>
        </a:graphic>
      </p:graphicFrame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6166CEE2-4BA4-4921-898E-377EE6066D23}"/>
              </a:ext>
            </a:extLst>
          </p:cNvPr>
          <p:cNvSpPr txBox="1"/>
          <p:nvPr/>
        </p:nvSpPr>
        <p:spPr>
          <a:xfrm>
            <a:off x="1552044" y="568081"/>
            <a:ext cx="3753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Suppl. </a:t>
            </a:r>
            <a:r>
              <a:rPr lang="it-IT" b="1" dirty="0" err="1"/>
              <a:t>Table</a:t>
            </a:r>
            <a:r>
              <a:rPr lang="it-IT" b="1" dirty="0"/>
              <a:t> 1. Social Interactions (SI)</a:t>
            </a:r>
          </a:p>
        </p:txBody>
      </p:sp>
      <p:sp>
        <p:nvSpPr>
          <p:cNvPr id="4" name="Rettangolo 3">
            <a:extLst>
              <a:ext uri="{FF2B5EF4-FFF2-40B4-BE49-F238E27FC236}">
                <a16:creationId xmlns:a16="http://schemas.microsoft.com/office/drawing/2014/main" id="{A47AFDB9-EC9F-4B6A-B9B6-BFE4F3E22D05}"/>
              </a:ext>
            </a:extLst>
          </p:cNvPr>
          <p:cNvSpPr/>
          <p:nvPr/>
        </p:nvSpPr>
        <p:spPr>
          <a:xfrm>
            <a:off x="81442" y="7588675"/>
            <a:ext cx="669511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Table 1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uration (s) and frequency of single social and non-social behaviors observed in the four experimental groups during SI. 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23834851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86508EE8-9D5D-4434-AE43-C752BEE435C9}"/>
              </a:ext>
            </a:extLst>
          </p:cNvPr>
          <p:cNvSpPr txBox="1"/>
          <p:nvPr/>
        </p:nvSpPr>
        <p:spPr>
          <a:xfrm>
            <a:off x="1102057" y="568078"/>
            <a:ext cx="4653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Suppl. </a:t>
            </a:r>
            <a:r>
              <a:rPr lang="it-IT" b="1" dirty="0" err="1"/>
              <a:t>Table</a:t>
            </a:r>
            <a:r>
              <a:rPr lang="it-IT" b="1" dirty="0"/>
              <a:t> 2. </a:t>
            </a:r>
            <a:r>
              <a:rPr lang="it-IT" b="1" dirty="0" err="1"/>
              <a:t>Porsolt</a:t>
            </a:r>
            <a:r>
              <a:rPr lang="it-IT" b="1" dirty="0"/>
              <a:t> Test (PT)</a:t>
            </a:r>
          </a:p>
        </p:txBody>
      </p:sp>
      <p:graphicFrame>
        <p:nvGraphicFramePr>
          <p:cNvPr id="2" name="Tabella 2">
            <a:extLst>
              <a:ext uri="{FF2B5EF4-FFF2-40B4-BE49-F238E27FC236}">
                <a16:creationId xmlns:a16="http://schemas.microsoft.com/office/drawing/2014/main" id="{B32F811F-C610-47DB-A0D9-C56565AF9C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687940"/>
              </p:ext>
            </p:extLst>
          </p:nvPr>
        </p:nvGraphicFramePr>
        <p:xfrm>
          <a:off x="990294" y="1531957"/>
          <a:ext cx="4877412" cy="424464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19353">
                  <a:extLst>
                    <a:ext uri="{9D8B030D-6E8A-4147-A177-3AD203B41FA5}">
                      <a16:colId xmlns:a16="http://schemas.microsoft.com/office/drawing/2014/main" val="3455223891"/>
                    </a:ext>
                  </a:extLst>
                </a:gridCol>
                <a:gridCol w="1219353">
                  <a:extLst>
                    <a:ext uri="{9D8B030D-6E8A-4147-A177-3AD203B41FA5}">
                      <a16:colId xmlns:a16="http://schemas.microsoft.com/office/drawing/2014/main" val="4134852329"/>
                    </a:ext>
                  </a:extLst>
                </a:gridCol>
                <a:gridCol w="121935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1935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83489">
                <a:tc>
                  <a:txBody>
                    <a:bodyPr/>
                    <a:lstStyle/>
                    <a:p>
                      <a:pPr algn="l"/>
                      <a:r>
                        <a:rPr lang="it-IT" dirty="0" err="1"/>
                        <a:t>Behavior</a:t>
                      </a:r>
                      <a:endParaRPr lang="it-IT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dirty="0" err="1"/>
                        <a:t>Diet</a:t>
                      </a:r>
                      <a:endParaRPr lang="it-IT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dirty="0" err="1"/>
                        <a:t>Lesion</a:t>
                      </a:r>
                      <a:endParaRPr lang="it-IT" baseline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dirty="0" err="1"/>
                        <a:t>Diet</a:t>
                      </a:r>
                      <a:r>
                        <a:rPr lang="it-IT" dirty="0"/>
                        <a:t> x </a:t>
                      </a:r>
                      <a:r>
                        <a:rPr lang="it-IT" dirty="0" err="1"/>
                        <a:t>Lesion</a:t>
                      </a:r>
                      <a:endParaRPr lang="it-IT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979573202"/>
                  </a:ext>
                </a:extLst>
              </a:tr>
              <a:tr h="383489">
                <a:tc gridSpan="4">
                  <a:txBody>
                    <a:bodyPr/>
                    <a:lstStyle/>
                    <a:p>
                      <a:pPr algn="ctr"/>
                      <a:r>
                        <a:rPr lang="it-IT" b="1" i="1" dirty="0"/>
                        <a:t>Duration</a:t>
                      </a:r>
                      <a:r>
                        <a:rPr lang="it-IT" dirty="0"/>
                        <a:t> 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3489">
                <a:tc>
                  <a:txBody>
                    <a:bodyPr/>
                    <a:lstStyle/>
                    <a:p>
                      <a:r>
                        <a:rPr lang="it-IT" b="1" dirty="0" err="1"/>
                        <a:t>Immobility</a:t>
                      </a:r>
                      <a:endParaRPr lang="it-IT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34, p=0.5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2.01, p=0.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06, p=0.8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3489">
                <a:tc>
                  <a:txBody>
                    <a:bodyPr/>
                    <a:lstStyle/>
                    <a:p>
                      <a:r>
                        <a:rPr lang="it-IT" b="1" dirty="0" err="1"/>
                        <a:t>Paddling</a:t>
                      </a:r>
                      <a:endParaRPr lang="it-IT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85, p=0.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1.10, p=0.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02, p=0.9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3489">
                <a:tc>
                  <a:txBody>
                    <a:bodyPr/>
                    <a:lstStyle/>
                    <a:p>
                      <a:r>
                        <a:rPr lang="it-IT" b="1" dirty="0" err="1"/>
                        <a:t>Swimming</a:t>
                      </a:r>
                      <a:endParaRPr lang="it-IT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19, p=0.6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04, p=0.8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89, p=0.3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83489">
                <a:tc>
                  <a:txBody>
                    <a:bodyPr/>
                    <a:lstStyle/>
                    <a:p>
                      <a:r>
                        <a:rPr lang="it-IT" b="1" dirty="0"/>
                        <a:t>Climb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24, p=0.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2.43, p=0.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38, p=0.5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83489">
                <a:tc gridSpan="4">
                  <a:txBody>
                    <a:bodyPr/>
                    <a:lstStyle/>
                    <a:p>
                      <a:pPr algn="ctr"/>
                      <a:r>
                        <a:rPr lang="it-IT" b="1" i="1" dirty="0"/>
                        <a:t>Frequency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83489">
                <a:tc>
                  <a:txBody>
                    <a:bodyPr/>
                    <a:lstStyle/>
                    <a:p>
                      <a:r>
                        <a:rPr lang="it-IT" b="1" dirty="0" err="1"/>
                        <a:t>Immobility</a:t>
                      </a:r>
                      <a:endParaRPr lang="it-IT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01, p=0.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02, p=0.8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02, p=0.8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8076283"/>
                  </a:ext>
                </a:extLst>
              </a:tr>
              <a:tr h="383489">
                <a:tc>
                  <a:txBody>
                    <a:bodyPr/>
                    <a:lstStyle/>
                    <a:p>
                      <a:r>
                        <a:rPr lang="it-IT" b="1" dirty="0" err="1"/>
                        <a:t>Paddling</a:t>
                      </a:r>
                      <a:endParaRPr lang="it-IT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27, p=0.6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07, p=0.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12, p=0.7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3497739"/>
                  </a:ext>
                </a:extLst>
              </a:tr>
              <a:tr h="383489">
                <a:tc>
                  <a:txBody>
                    <a:bodyPr/>
                    <a:lstStyle/>
                    <a:p>
                      <a:r>
                        <a:rPr lang="it-IT" b="1" dirty="0" err="1"/>
                        <a:t>Swimming</a:t>
                      </a:r>
                      <a:endParaRPr lang="it-IT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84, p=0.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04, p=0.8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04, p=0.8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2109835"/>
                  </a:ext>
                </a:extLst>
              </a:tr>
              <a:tr h="409755">
                <a:tc>
                  <a:txBody>
                    <a:bodyPr/>
                    <a:lstStyle/>
                    <a:p>
                      <a:r>
                        <a:rPr lang="it-IT" b="1" dirty="0"/>
                        <a:t>Climb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1.38, p=0.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001, p=0.9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sz="1000" dirty="0"/>
                        <a:t>F</a:t>
                      </a:r>
                      <a:r>
                        <a:rPr lang="it-IT" sz="1000" baseline="-25000" dirty="0"/>
                        <a:t>1,37</a:t>
                      </a:r>
                      <a:r>
                        <a:rPr lang="it-IT" sz="1000" dirty="0"/>
                        <a:t>=0.26, p=0.6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54871505"/>
                  </a:ext>
                </a:extLst>
              </a:tr>
            </a:tbl>
          </a:graphicData>
        </a:graphic>
      </p:graphicFrame>
      <p:sp>
        <p:nvSpPr>
          <p:cNvPr id="4" name="Rettangolo 3">
            <a:extLst>
              <a:ext uri="{FF2B5EF4-FFF2-40B4-BE49-F238E27FC236}">
                <a16:creationId xmlns:a16="http://schemas.microsoft.com/office/drawing/2014/main" id="{3AE86963-A919-4945-B07F-3B7F85385041}"/>
              </a:ext>
            </a:extLst>
          </p:cNvPr>
          <p:cNvSpPr/>
          <p:nvPr/>
        </p:nvSpPr>
        <p:spPr>
          <a:xfrm>
            <a:off x="81442" y="6346725"/>
            <a:ext cx="669511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Table </a:t>
            </a:r>
            <a:r>
              <a:rPr lang="en-US" sz="1400" b="1" dirty="0"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uration (s) and frequency of single strategies displayed by the four experimental groups during PT. 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38304704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5</TotalTime>
  <Words>665</Words>
  <Application>Microsoft Office PowerPoint</Application>
  <PresentationFormat>A4 (21x29,7 cm)</PresentationFormat>
  <Paragraphs>106</Paragraphs>
  <Slides>8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37</cp:revision>
  <dcterms:created xsi:type="dcterms:W3CDTF">2019-12-13T16:38:15Z</dcterms:created>
  <dcterms:modified xsi:type="dcterms:W3CDTF">2020-03-02T14:29:28Z</dcterms:modified>
</cp:coreProperties>
</file>